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B3B3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431" autoAdjust="0"/>
    <p:restoredTop sz="94660"/>
  </p:normalViewPr>
  <p:slideViewPr>
    <p:cSldViewPr snapToGrid="0">
      <p:cViewPr varScale="1">
        <p:scale>
          <a:sx n="160" d="100"/>
          <a:sy n="160" d="100"/>
        </p:scale>
        <p:origin x="1254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598094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30187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8097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62432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8008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718310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15081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79256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10071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4137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089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97674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Image 11" descr="Une image contenant texte, diagramme, capture d’écran, Police&#10;&#10;Description générée automatiquement">
            <a:extLst>
              <a:ext uri="{FF2B5EF4-FFF2-40B4-BE49-F238E27FC236}">
                <a16:creationId xmlns:a16="http://schemas.microsoft.com/office/drawing/2014/main" id="{3FF18228-BFBB-48A8-1CF1-C10C5E664BF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096"/>
          <a:stretch/>
        </p:blipFill>
        <p:spPr>
          <a:xfrm>
            <a:off x="444617" y="171274"/>
            <a:ext cx="10973178" cy="6313415"/>
          </a:xfrm>
          <a:prstGeom prst="rect">
            <a:avLst/>
          </a:prstGeom>
        </p:spPr>
      </p:pic>
      <p:sp>
        <p:nvSpPr>
          <p:cNvPr id="36" name="Rectangle 35">
            <a:extLst>
              <a:ext uri="{FF2B5EF4-FFF2-40B4-BE49-F238E27FC236}">
                <a16:creationId xmlns:a16="http://schemas.microsoft.com/office/drawing/2014/main" id="{4D3CA419-1446-FABA-04C6-BA6B76BF6888}"/>
              </a:ext>
            </a:extLst>
          </p:cNvPr>
          <p:cNvSpPr/>
          <p:nvPr/>
        </p:nvSpPr>
        <p:spPr>
          <a:xfrm>
            <a:off x="1047811" y="6320609"/>
            <a:ext cx="10211860" cy="18661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FB2D90A4-D369-8207-85A8-5639E5BDE079}"/>
              </a:ext>
            </a:extLst>
          </p:cNvPr>
          <p:cNvSpPr/>
          <p:nvPr/>
        </p:nvSpPr>
        <p:spPr>
          <a:xfrm>
            <a:off x="1966259" y="322729"/>
            <a:ext cx="2542025" cy="290071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91DC6C1E-7185-3B4C-600B-0740BF45D97C}"/>
              </a:ext>
            </a:extLst>
          </p:cNvPr>
          <p:cNvSpPr txBox="1"/>
          <p:nvPr/>
        </p:nvSpPr>
        <p:spPr>
          <a:xfrm>
            <a:off x="-1077885" y="2266268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omplement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cascade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41060465-8CE0-DCCD-2F64-DBD7645FC3DB}"/>
              </a:ext>
            </a:extLst>
          </p:cNvPr>
          <p:cNvSpPr/>
          <p:nvPr/>
        </p:nvSpPr>
        <p:spPr>
          <a:xfrm>
            <a:off x="4524189" y="3275106"/>
            <a:ext cx="2157506" cy="27611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318A40DF-50E9-3A23-0399-D54DEC97D870}"/>
              </a:ext>
            </a:extLst>
          </p:cNvPr>
          <p:cNvSpPr txBox="1"/>
          <p:nvPr/>
        </p:nvSpPr>
        <p:spPr>
          <a:xfrm>
            <a:off x="4484380" y="3232922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160"/>
              </a:spcAft>
            </a:pP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GABA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receptor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activation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C3ADD136-0297-FC29-51E3-13F8E8170FDA}"/>
              </a:ext>
            </a:extLst>
          </p:cNvPr>
          <p:cNvSpPr txBox="1"/>
          <p:nvPr/>
        </p:nvSpPr>
        <p:spPr>
          <a:xfrm>
            <a:off x="4509249" y="4874994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160"/>
              </a:spcAft>
            </a:pP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Acetylcholine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Binding and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Downstream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Events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9805C39B-9FB8-761F-F74D-D34443C950D1}"/>
              </a:ext>
            </a:extLst>
          </p:cNvPr>
          <p:cNvSpPr txBox="1"/>
          <p:nvPr/>
        </p:nvSpPr>
        <p:spPr>
          <a:xfrm>
            <a:off x="4515225" y="5071276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160"/>
              </a:spcAft>
            </a:pP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Respiratory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electron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transport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D7783C31-65EB-A829-A60C-3160FE3BB5EE}"/>
              </a:ext>
            </a:extLst>
          </p:cNvPr>
          <p:cNvSpPr txBox="1"/>
          <p:nvPr/>
        </p:nvSpPr>
        <p:spPr>
          <a:xfrm>
            <a:off x="4521201" y="5251471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160"/>
              </a:spcAft>
            </a:pP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Potassium Channels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C10DE268-D4E4-8FA6-7C0C-3A057ECF15FD}"/>
              </a:ext>
            </a:extLst>
          </p:cNvPr>
          <p:cNvSpPr txBox="1"/>
          <p:nvPr/>
        </p:nvSpPr>
        <p:spPr>
          <a:xfrm>
            <a:off x="4521201" y="5442573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160"/>
              </a:spcAft>
            </a:pP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Muscle contraction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E0E87EEE-B029-0F84-D146-4C5F0E5DF875}"/>
              </a:ext>
            </a:extLst>
          </p:cNvPr>
          <p:cNvSpPr txBox="1"/>
          <p:nvPr/>
        </p:nvSpPr>
        <p:spPr>
          <a:xfrm>
            <a:off x="4524189" y="5633924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160"/>
              </a:spcAft>
            </a:pP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Neuronal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ytem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5EAEF2FA-2D61-C1CF-D77C-DA719AE17163}"/>
              </a:ext>
            </a:extLst>
          </p:cNvPr>
          <p:cNvSpPr txBox="1"/>
          <p:nvPr/>
        </p:nvSpPr>
        <p:spPr>
          <a:xfrm>
            <a:off x="4515225" y="5821465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160"/>
              </a:spcAft>
            </a:pP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itric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(TCA) cycle and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respiratory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electron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transport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14A575D0-D9D5-1B03-A347-CC0A91584503}"/>
              </a:ext>
            </a:extLst>
          </p:cNvPr>
          <p:cNvSpPr txBox="1"/>
          <p:nvPr/>
        </p:nvSpPr>
        <p:spPr>
          <a:xfrm>
            <a:off x="4490356" y="3963938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160"/>
              </a:spcAft>
            </a:pP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Glucose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metabolism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14053957-7558-A70F-6FDC-955F0DEC4F4B}"/>
              </a:ext>
            </a:extLst>
          </p:cNvPr>
          <p:cNvSpPr txBox="1"/>
          <p:nvPr/>
        </p:nvSpPr>
        <p:spPr>
          <a:xfrm>
            <a:off x="4496332" y="4147471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160"/>
              </a:spcAft>
            </a:pP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ardiac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conduction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144EC9B2-608C-11FA-31B5-F959D3D53470}"/>
              </a:ext>
            </a:extLst>
          </p:cNvPr>
          <p:cNvSpPr txBox="1"/>
          <p:nvPr/>
        </p:nvSpPr>
        <p:spPr>
          <a:xfrm>
            <a:off x="4503802" y="4342908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160"/>
              </a:spcAft>
            </a:pP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Phase 4 –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resting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membrane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potential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15DB0B46-1909-8B98-3BC0-AE0E2950533C}"/>
              </a:ext>
            </a:extLst>
          </p:cNvPr>
          <p:cNvSpPr txBox="1"/>
          <p:nvPr/>
        </p:nvSpPr>
        <p:spPr>
          <a:xfrm>
            <a:off x="4496332" y="4515413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160"/>
              </a:spcAft>
            </a:pP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omplex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I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biogenesis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03DBA159-8381-582F-C903-4F87D779C14C}"/>
              </a:ext>
            </a:extLst>
          </p:cNvPr>
          <p:cNvSpPr txBox="1"/>
          <p:nvPr/>
        </p:nvSpPr>
        <p:spPr>
          <a:xfrm>
            <a:off x="4484380" y="3412083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160"/>
              </a:spcAft>
            </a:pP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Class A/1 (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Rhodopsin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-like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receptor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9642D54B-AE5D-A7E2-6BC9-3645C4C8C315}"/>
              </a:ext>
            </a:extLst>
          </p:cNvPr>
          <p:cNvSpPr txBox="1"/>
          <p:nvPr/>
        </p:nvSpPr>
        <p:spPr>
          <a:xfrm>
            <a:off x="4484380" y="3591229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160"/>
              </a:spcAft>
            </a:pP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Inhibition of voltage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gate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Ca2+ channels via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Gbeta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/gamma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ubunits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ABC517B0-2FF5-0B54-0CF1-E353FE5AB178}"/>
              </a:ext>
            </a:extLst>
          </p:cNvPr>
          <p:cNvSpPr txBox="1"/>
          <p:nvPr/>
        </p:nvSpPr>
        <p:spPr>
          <a:xfrm>
            <a:off x="4484380" y="3779866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160"/>
              </a:spcAft>
            </a:pP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G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gate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Potassium channels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176E2EB8-31F4-1531-7FEC-46561AA896EA}"/>
              </a:ext>
            </a:extLst>
          </p:cNvPr>
          <p:cNvSpPr txBox="1"/>
          <p:nvPr/>
        </p:nvSpPr>
        <p:spPr>
          <a:xfrm>
            <a:off x="4512237" y="4698407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160"/>
              </a:spcAft>
            </a:pP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Activation of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Nicotinic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Acetylcholine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Receptors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4E99BD47-1911-E588-BE64-1CA2D55ADFC8}"/>
              </a:ext>
            </a:extLst>
          </p:cNvPr>
          <p:cNvSpPr txBox="1"/>
          <p:nvPr/>
        </p:nvSpPr>
        <p:spPr>
          <a:xfrm>
            <a:off x="-1112683" y="434537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Immunoregulatory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interactions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Lymphoi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/non-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Lymphoi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E3CD3499-0BCB-E3B4-8C4F-D0AF7AFE6B07}"/>
              </a:ext>
            </a:extLst>
          </p:cNvPr>
          <p:cNvSpPr txBox="1"/>
          <p:nvPr/>
        </p:nvSpPr>
        <p:spPr>
          <a:xfrm>
            <a:off x="-1112683" y="618070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Translocation of ZAP-70 to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Immunological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synapse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A5155F59-D6E2-3538-6D75-95C7123C6E27}"/>
              </a:ext>
            </a:extLst>
          </p:cNvPr>
          <p:cNvSpPr txBox="1"/>
          <p:nvPr/>
        </p:nvSpPr>
        <p:spPr>
          <a:xfrm>
            <a:off x="-1112683" y="810658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Class A/1 (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Rhodopsin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-like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receptor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35FD49A6-ADF1-54E4-6854-5332E204A126}"/>
              </a:ext>
            </a:extLst>
          </p:cNvPr>
          <p:cNvSpPr txBox="1"/>
          <p:nvPr/>
        </p:nvSpPr>
        <p:spPr>
          <a:xfrm>
            <a:off x="-1130082" y="1153392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TCR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ignaling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7028B64F-BC75-FE78-1091-20BA045135C1}"/>
              </a:ext>
            </a:extLst>
          </p:cNvPr>
          <p:cNvSpPr txBox="1"/>
          <p:nvPr/>
        </p:nvSpPr>
        <p:spPr>
          <a:xfrm>
            <a:off x="-1112683" y="1336925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TNF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bin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their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physiological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receptors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5410612F-90BE-6484-8EAC-66743A878F26}"/>
              </a:ext>
            </a:extLst>
          </p:cNvPr>
          <p:cNvSpPr txBox="1"/>
          <p:nvPr/>
        </p:nvSpPr>
        <p:spPr>
          <a:xfrm>
            <a:off x="-1095284" y="1532857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Interferon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gamma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ignaling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EA9B0552-440A-1718-208E-F341AFAD0E9C}"/>
              </a:ext>
            </a:extLst>
          </p:cNvPr>
          <p:cNvSpPr txBox="1"/>
          <p:nvPr/>
        </p:nvSpPr>
        <p:spPr>
          <a:xfrm>
            <a:off x="-1077885" y="1723959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Antigen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activate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B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Receptor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(BCR) 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971DC97F-D385-6316-E811-A0467B1198A1}"/>
              </a:ext>
            </a:extLst>
          </p:cNvPr>
          <p:cNvSpPr txBox="1"/>
          <p:nvPr/>
        </p:nvSpPr>
        <p:spPr>
          <a:xfrm>
            <a:off x="-1112683" y="1903581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FCGR activation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F2BBD8F9-0E66-BF02-B06E-BA64B97CFE85}"/>
              </a:ext>
            </a:extLst>
          </p:cNvPr>
          <p:cNvSpPr txBox="1"/>
          <p:nvPr/>
        </p:nvSpPr>
        <p:spPr>
          <a:xfrm>
            <a:off x="-1106707" y="2650656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Inflammasomes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49E0B936-D0DB-E1AA-1EEB-B4940ED12273}"/>
              </a:ext>
            </a:extLst>
          </p:cNvPr>
          <p:cNvSpPr txBox="1"/>
          <p:nvPr/>
        </p:nvSpPr>
        <p:spPr>
          <a:xfrm>
            <a:off x="-1077885" y="3015534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Trafficking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processing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of endosomal TLR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641F5887-DC6A-B85B-6E41-B07D4B9CF665}"/>
              </a:ext>
            </a:extLst>
          </p:cNvPr>
          <p:cNvSpPr txBox="1"/>
          <p:nvPr/>
        </p:nvSpPr>
        <p:spPr>
          <a:xfrm>
            <a:off x="-1077885" y="2445770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ignaling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by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Interleukins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3EFBA1B2-53B6-8712-A58F-B687D32B8D51}"/>
              </a:ext>
            </a:extLst>
          </p:cNvPr>
          <p:cNvSpPr txBox="1"/>
          <p:nvPr/>
        </p:nvSpPr>
        <p:spPr>
          <a:xfrm>
            <a:off x="-1095284" y="2087114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Interleukin-10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ignaling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A313ED8E-C690-8A22-49BE-3401ED1B324A}"/>
              </a:ext>
            </a:extLst>
          </p:cNvPr>
          <p:cNvSpPr txBox="1"/>
          <p:nvPr/>
        </p:nvSpPr>
        <p:spPr>
          <a:xfrm>
            <a:off x="-1095284" y="2831643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RHO GTPases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Activate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NADPH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Oxidase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7ACF12DD-B91F-EDA6-652B-3C49CB534012}"/>
              </a:ext>
            </a:extLst>
          </p:cNvPr>
          <p:cNvSpPr txBox="1"/>
          <p:nvPr/>
        </p:nvSpPr>
        <p:spPr>
          <a:xfrm>
            <a:off x="-1116632" y="994191"/>
            <a:ext cx="5633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GPVI-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mediate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activation cascade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0BF726D4-6E6A-09E0-C3AC-F71DF92A386F}"/>
              </a:ext>
            </a:extLst>
          </p:cNvPr>
          <p:cNvSpPr txBox="1"/>
          <p:nvPr/>
        </p:nvSpPr>
        <p:spPr>
          <a:xfrm>
            <a:off x="1047811" y="6261002"/>
            <a:ext cx="103134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50                                           25                         10      5        0       5       10                        25                                           50                                                                                          100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C6C8FDA8-3942-D4D8-410B-61AFCC8CDFE6}"/>
              </a:ext>
            </a:extLst>
          </p:cNvPr>
          <p:cNvSpPr txBox="1"/>
          <p:nvPr/>
        </p:nvSpPr>
        <p:spPr>
          <a:xfrm>
            <a:off x="4053976" y="6521123"/>
            <a:ext cx="15489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lang="fr-FR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(p-value)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1BA31C2B-0C2E-5008-A533-5AB252B187FC}"/>
              </a:ext>
            </a:extLst>
          </p:cNvPr>
          <p:cNvSpPr/>
          <p:nvPr/>
        </p:nvSpPr>
        <p:spPr>
          <a:xfrm>
            <a:off x="418347" y="396819"/>
            <a:ext cx="203200" cy="59237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678462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0</TotalTime>
  <Words>148</Words>
  <Application>Microsoft Office PowerPoint</Application>
  <PresentationFormat>Grand écran</PresentationFormat>
  <Paragraphs>3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auline Brochet</dc:creator>
  <cp:lastModifiedBy>Pauline Brochet</cp:lastModifiedBy>
  <cp:revision>13</cp:revision>
  <dcterms:created xsi:type="dcterms:W3CDTF">2023-09-28T23:06:01Z</dcterms:created>
  <dcterms:modified xsi:type="dcterms:W3CDTF">2023-10-15T13:27:41Z</dcterms:modified>
</cp:coreProperties>
</file>